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4" r:id="rId2"/>
    <p:sldId id="276" r:id="rId3"/>
    <p:sldId id="285" r:id="rId4"/>
    <p:sldId id="279" r:id="rId5"/>
    <p:sldId id="280" r:id="rId6"/>
  </p:sldIdLst>
  <p:sldSz cx="12192000" cy="6858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2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97F4AE-7921-4980-8ADE-586D02A474DA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9D7937-9533-42D6-8808-3FEB1289C50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57473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ADDITIONAL FIGURE 1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9D7937-9533-42D6-8808-3FEB1289C50E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33290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ADDITIONAL FIGURE 2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9D7937-9533-42D6-8808-3FEB1289C50E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499126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ADDITIONAL FIGURE 3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9D7937-9533-42D6-8808-3FEB1289C50E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56119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ADDITIONAL FIGURE 4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9D7937-9533-42D6-8808-3FEB1289C50E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942008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ADDITIONAL FIGURE 5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9D7937-9533-42D6-8808-3FEB1289C50E}" type="slidenum">
              <a:rPr lang="it-IT" smtClean="0"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7976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3617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1390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277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03806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9654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22534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4135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9963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8233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9379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9229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B5AA7-B1D1-4F1D-8F15-01FA2B08A4A4}" type="datetimeFigureOut">
              <a:rPr lang="it-IT" smtClean="0"/>
              <a:t>27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88E03A3-82B8-4DF6-829B-28A88ED5C0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6534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po 21">
            <a:extLst>
              <a:ext uri="{FF2B5EF4-FFF2-40B4-BE49-F238E27FC236}">
                <a16:creationId xmlns:a16="http://schemas.microsoft.com/office/drawing/2014/main" id="{D7CA251F-469F-B300-7310-C65D07665DE0}"/>
              </a:ext>
            </a:extLst>
          </p:cNvPr>
          <p:cNvGrpSpPr/>
          <p:nvPr/>
        </p:nvGrpSpPr>
        <p:grpSpPr>
          <a:xfrm>
            <a:off x="-900898" y="-867785"/>
            <a:ext cx="14090389" cy="6201540"/>
            <a:chOff x="-900898" y="-867785"/>
            <a:chExt cx="14090389" cy="6201540"/>
          </a:xfrm>
        </p:grpSpPr>
        <p:grpSp>
          <p:nvGrpSpPr>
            <p:cNvPr id="2" name="Gruppo 1">
              <a:extLst>
                <a:ext uri="{FF2B5EF4-FFF2-40B4-BE49-F238E27FC236}">
                  <a16:creationId xmlns:a16="http://schemas.microsoft.com/office/drawing/2014/main" id="{01E9EE64-2BFD-C08B-5E43-4393A7B93209}"/>
                </a:ext>
              </a:extLst>
            </p:cNvPr>
            <p:cNvGrpSpPr/>
            <p:nvPr/>
          </p:nvGrpSpPr>
          <p:grpSpPr>
            <a:xfrm>
              <a:off x="-900898" y="-867785"/>
              <a:ext cx="14090389" cy="6201540"/>
              <a:chOff x="-900898" y="-867785"/>
              <a:chExt cx="14090389" cy="6201540"/>
            </a:xfrm>
          </p:grpSpPr>
          <p:graphicFrame>
            <p:nvGraphicFramePr>
              <p:cNvPr id="3" name="Oggetto 2">
                <a:extLst>
                  <a:ext uri="{FF2B5EF4-FFF2-40B4-BE49-F238E27FC236}">
                    <a16:creationId xmlns:a16="http://schemas.microsoft.com/office/drawing/2014/main" id="{FFF1B4B1-54BD-AF2B-EA0B-9F88BDDCE6D9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-892762" y="-831725"/>
              <a:ext cx="5436000" cy="341493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3" imgW="7113057" imgH="4469283" progId="Prism8.Document">
                      <p:embed/>
                    </p:oleObj>
                  </mc:Choice>
                  <mc:Fallback>
                    <p:oleObj name="Prism 8" r:id="rId3" imgW="7113057" imgH="4469283" progId="Prism8.Document">
                      <p:embed/>
                      <p:pic>
                        <p:nvPicPr>
                          <p:cNvPr id="3" name="Oggetto 2">
                            <a:extLst>
                              <a:ext uri="{FF2B5EF4-FFF2-40B4-BE49-F238E27FC236}">
                                <a16:creationId xmlns:a16="http://schemas.microsoft.com/office/drawing/2014/main" id="{FFF1B4B1-54BD-AF2B-EA0B-9F88BDDCE6D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-892762" y="-831725"/>
                            <a:ext cx="5436000" cy="341493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ggetto 4">
                <a:extLst>
                  <a:ext uri="{FF2B5EF4-FFF2-40B4-BE49-F238E27FC236}">
                    <a16:creationId xmlns:a16="http://schemas.microsoft.com/office/drawing/2014/main" id="{2D603FB0-6DA3-4269-2E7E-B907ABCE34A1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087854" y="-795667"/>
              <a:ext cx="5332549" cy="33499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5" imgW="7113057" imgH="4469283" progId="Prism8.Document">
                      <p:embed/>
                    </p:oleObj>
                  </mc:Choice>
                  <mc:Fallback>
                    <p:oleObj name="Prism 8" r:id="rId5" imgW="7113057" imgH="4469283" progId="Prism8.Document">
                      <p:embed/>
                      <p:pic>
                        <p:nvPicPr>
                          <p:cNvPr id="5" name="Oggetto 4">
                            <a:extLst>
                              <a:ext uri="{FF2B5EF4-FFF2-40B4-BE49-F238E27FC236}">
                                <a16:creationId xmlns:a16="http://schemas.microsoft.com/office/drawing/2014/main" id="{2D603FB0-6DA3-4269-2E7E-B907ABCE34A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2087854" y="-795667"/>
                            <a:ext cx="5332549" cy="33499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ggetto 5">
                <a:extLst>
                  <a:ext uri="{FF2B5EF4-FFF2-40B4-BE49-F238E27FC236}">
                    <a16:creationId xmlns:a16="http://schemas.microsoft.com/office/drawing/2014/main" id="{3F1AC794-E2AC-1A33-95C9-8BD9F743C93B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5035361" y="-742195"/>
              <a:ext cx="5247429" cy="329647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7" imgW="7113057" imgH="4469283" progId="Prism8.Document">
                      <p:embed/>
                    </p:oleObj>
                  </mc:Choice>
                  <mc:Fallback>
                    <p:oleObj name="Prism 8" r:id="rId7" imgW="7113057" imgH="4469283" progId="Prism8.Document">
                      <p:embed/>
                      <p:pic>
                        <p:nvPicPr>
                          <p:cNvPr id="6" name="Oggetto 5">
                            <a:extLst>
                              <a:ext uri="{FF2B5EF4-FFF2-40B4-BE49-F238E27FC236}">
                                <a16:creationId xmlns:a16="http://schemas.microsoft.com/office/drawing/2014/main" id="{3F1AC794-E2AC-1A33-95C9-8BD9F743C93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5035361" y="-742195"/>
                            <a:ext cx="5247429" cy="329647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" name="Oggetto 7">
                <a:extLst>
                  <a:ext uri="{FF2B5EF4-FFF2-40B4-BE49-F238E27FC236}">
                    <a16:creationId xmlns:a16="http://schemas.microsoft.com/office/drawing/2014/main" id="{C80BE28C-8AD7-C0A4-EA2D-A0A660E67497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7753491" y="-867785"/>
              <a:ext cx="5436000" cy="341493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9" imgW="7113057" imgH="4469283" progId="Prism8.Document">
                      <p:embed/>
                    </p:oleObj>
                  </mc:Choice>
                  <mc:Fallback>
                    <p:oleObj name="Prism 8" r:id="rId9" imgW="7113057" imgH="4469283" progId="Prism8.Document">
                      <p:embed/>
                      <p:pic>
                        <p:nvPicPr>
                          <p:cNvPr id="8" name="Oggetto 7">
                            <a:extLst>
                              <a:ext uri="{FF2B5EF4-FFF2-40B4-BE49-F238E27FC236}">
                                <a16:creationId xmlns:a16="http://schemas.microsoft.com/office/drawing/2014/main" id="{C80BE28C-8AD7-C0A4-EA2D-A0A660E6749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7753491" y="-867785"/>
                            <a:ext cx="5436000" cy="341493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9" name="Oggetto 8">
                <a:extLst>
                  <a:ext uri="{FF2B5EF4-FFF2-40B4-BE49-F238E27FC236}">
                    <a16:creationId xmlns:a16="http://schemas.microsoft.com/office/drawing/2014/main" id="{E1FD093C-BE95-0741-A72B-6A1B8B110391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-900898" y="1896940"/>
              <a:ext cx="5508000" cy="34368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1" imgW="7113057" imgH="4439047" progId="Prism8.Document">
                      <p:embed/>
                    </p:oleObj>
                  </mc:Choice>
                  <mc:Fallback>
                    <p:oleObj name="Prism 8" r:id="rId11" imgW="7113057" imgH="4439047" progId="Prism8.Document">
                      <p:embed/>
                      <p:pic>
                        <p:nvPicPr>
                          <p:cNvPr id="9" name="Oggetto 8">
                            <a:extLst>
                              <a:ext uri="{FF2B5EF4-FFF2-40B4-BE49-F238E27FC236}">
                                <a16:creationId xmlns:a16="http://schemas.microsoft.com/office/drawing/2014/main" id="{E1FD093C-BE95-0741-A72B-6A1B8B11039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-900898" y="1896940"/>
                            <a:ext cx="5508000" cy="343681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0" name="Oggetto 9">
                <a:extLst>
                  <a:ext uri="{FF2B5EF4-FFF2-40B4-BE49-F238E27FC236}">
                    <a16:creationId xmlns:a16="http://schemas.microsoft.com/office/drawing/2014/main" id="{3FCAAEA8-EBF6-B018-6AF3-3339E8E943F2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017415" y="1852014"/>
              <a:ext cx="5580000" cy="348174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3" imgW="7113057" imgH="4439047" progId="Prism8.Document">
                      <p:embed/>
                    </p:oleObj>
                  </mc:Choice>
                  <mc:Fallback>
                    <p:oleObj name="Prism 8" r:id="rId13" imgW="7113057" imgH="4439047" progId="Prism8.Document">
                      <p:embed/>
                      <p:pic>
                        <p:nvPicPr>
                          <p:cNvPr id="10" name="Oggetto 9">
                            <a:extLst>
                              <a:ext uri="{FF2B5EF4-FFF2-40B4-BE49-F238E27FC236}">
                                <a16:creationId xmlns:a16="http://schemas.microsoft.com/office/drawing/2014/main" id="{3FCAAEA8-EBF6-B018-6AF3-3339E8E943F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2017415" y="1852014"/>
                            <a:ext cx="5580000" cy="348174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1" name="Oggetto 10">
                <a:extLst>
                  <a:ext uri="{FF2B5EF4-FFF2-40B4-BE49-F238E27FC236}">
                    <a16:creationId xmlns:a16="http://schemas.microsoft.com/office/drawing/2014/main" id="{2F4E4D19-596F-0E88-1A83-CDF85CB5BD74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5005461" y="1841755"/>
              <a:ext cx="5351783" cy="34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5" imgW="7113057" imgH="4439047" progId="Prism8.Document">
                      <p:embed/>
                    </p:oleObj>
                  </mc:Choice>
                  <mc:Fallback>
                    <p:oleObj name="Prism 8" r:id="rId15" imgW="7113057" imgH="4439047" progId="Prism8.Document">
                      <p:embed/>
                      <p:pic>
                        <p:nvPicPr>
                          <p:cNvPr id="11" name="Oggetto 10">
                            <a:extLst>
                              <a:ext uri="{FF2B5EF4-FFF2-40B4-BE49-F238E27FC236}">
                                <a16:creationId xmlns:a16="http://schemas.microsoft.com/office/drawing/2014/main" id="{2F4E4D19-596F-0E88-1A83-CDF85CB5BD7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5005461" y="1841755"/>
                            <a:ext cx="5351783" cy="3492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2" name="Oggetto 11">
                <a:extLst>
                  <a:ext uri="{FF2B5EF4-FFF2-40B4-BE49-F238E27FC236}">
                    <a16:creationId xmlns:a16="http://schemas.microsoft.com/office/drawing/2014/main" id="{3C87DB46-2679-3B00-B240-F7B64B644B36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7807491" y="1953096"/>
              <a:ext cx="5328000" cy="332450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7" imgW="7113057" imgH="4439047" progId="Prism8.Document">
                      <p:embed/>
                    </p:oleObj>
                  </mc:Choice>
                  <mc:Fallback>
                    <p:oleObj name="Prism 8" r:id="rId17" imgW="7113057" imgH="4439047" progId="Prism8.Document">
                      <p:embed/>
                      <p:pic>
                        <p:nvPicPr>
                          <p:cNvPr id="12" name="Oggetto 11">
                            <a:extLst>
                              <a:ext uri="{FF2B5EF4-FFF2-40B4-BE49-F238E27FC236}">
                                <a16:creationId xmlns:a16="http://schemas.microsoft.com/office/drawing/2014/main" id="{3C87DB46-2679-3B00-B240-F7B64B644B3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7807491" y="1953096"/>
                            <a:ext cx="5328000" cy="332450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6" name="Gruppo 15">
              <a:extLst>
                <a:ext uri="{FF2B5EF4-FFF2-40B4-BE49-F238E27FC236}">
                  <a16:creationId xmlns:a16="http://schemas.microsoft.com/office/drawing/2014/main" id="{A182D6B4-31E6-DDDE-7F8E-762F14A97131}"/>
                </a:ext>
              </a:extLst>
            </p:cNvPr>
            <p:cNvGrpSpPr/>
            <p:nvPr/>
          </p:nvGrpSpPr>
          <p:grpSpPr>
            <a:xfrm>
              <a:off x="288632" y="240763"/>
              <a:ext cx="8898530" cy="250080"/>
              <a:chOff x="288632" y="240763"/>
              <a:chExt cx="8898530" cy="250080"/>
            </a:xfrm>
          </p:grpSpPr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874CD99C-332A-3BB9-B53D-0BD3585FC66D}"/>
                  </a:ext>
                </a:extLst>
              </p:cNvPr>
              <p:cNvSpPr txBox="1"/>
              <p:nvPr/>
            </p:nvSpPr>
            <p:spPr>
              <a:xfrm>
                <a:off x="288632" y="244622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A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D8AF7287-7D5C-85F7-598F-7934DC53054B}"/>
                  </a:ext>
                </a:extLst>
              </p:cNvPr>
              <p:cNvSpPr txBox="1"/>
              <p:nvPr/>
            </p:nvSpPr>
            <p:spPr>
              <a:xfrm>
                <a:off x="3260370" y="241460"/>
                <a:ext cx="2616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B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76B4F84D-DCEF-3720-E98B-3D754E9D523C}"/>
                  </a:ext>
                </a:extLst>
              </p:cNvPr>
              <p:cNvSpPr txBox="1"/>
              <p:nvPr/>
            </p:nvSpPr>
            <p:spPr>
              <a:xfrm>
                <a:off x="6163171" y="240764"/>
                <a:ext cx="2728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C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7DCC3964-3E69-D365-06CB-143503EF0A62}"/>
                  </a:ext>
                </a:extLst>
              </p:cNvPr>
              <p:cNvSpPr txBox="1"/>
              <p:nvPr/>
            </p:nvSpPr>
            <p:spPr>
              <a:xfrm>
                <a:off x="8914330" y="240763"/>
                <a:ext cx="2728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D</a:t>
                </a:r>
              </a:p>
            </p:txBody>
          </p:sp>
        </p:grpSp>
        <p:grpSp>
          <p:nvGrpSpPr>
            <p:cNvPr id="17" name="Gruppo 16">
              <a:extLst>
                <a:ext uri="{FF2B5EF4-FFF2-40B4-BE49-F238E27FC236}">
                  <a16:creationId xmlns:a16="http://schemas.microsoft.com/office/drawing/2014/main" id="{8C21ADC9-1B6C-43D0-07C7-3A28E009B466}"/>
                </a:ext>
              </a:extLst>
            </p:cNvPr>
            <p:cNvGrpSpPr/>
            <p:nvPr/>
          </p:nvGrpSpPr>
          <p:grpSpPr>
            <a:xfrm>
              <a:off x="304863" y="2965569"/>
              <a:ext cx="8901736" cy="250080"/>
              <a:chOff x="288632" y="240763"/>
              <a:chExt cx="8901736" cy="250080"/>
            </a:xfrm>
          </p:grpSpPr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02B7C2DB-7A0A-6886-6087-A970E039E00F}"/>
                  </a:ext>
                </a:extLst>
              </p:cNvPr>
              <p:cNvSpPr txBox="1"/>
              <p:nvPr/>
            </p:nvSpPr>
            <p:spPr>
              <a:xfrm>
                <a:off x="288632" y="24462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E</a:t>
                </a: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3F5FFC8C-C58E-CED4-476D-BBF68193B4B0}"/>
                  </a:ext>
                </a:extLst>
              </p:cNvPr>
              <p:cNvSpPr txBox="1"/>
              <p:nvPr/>
            </p:nvSpPr>
            <p:spPr>
              <a:xfrm>
                <a:off x="3260370" y="241460"/>
                <a:ext cx="2519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F</a:t>
                </a:r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36A46A4C-36BA-FEDC-36C3-FB6DD0FF55C7}"/>
                  </a:ext>
                </a:extLst>
              </p:cNvPr>
              <p:cNvSpPr txBox="1"/>
              <p:nvPr/>
            </p:nvSpPr>
            <p:spPr>
              <a:xfrm>
                <a:off x="6163171" y="240764"/>
                <a:ext cx="2760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G</a:t>
                </a:r>
              </a:p>
            </p:txBody>
          </p: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483488FE-A6A6-9340-E687-BC2FA6407BAE}"/>
                  </a:ext>
                </a:extLst>
              </p:cNvPr>
              <p:cNvSpPr txBox="1"/>
              <p:nvPr/>
            </p:nvSpPr>
            <p:spPr>
              <a:xfrm>
                <a:off x="8914330" y="240763"/>
                <a:ext cx="2760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H</a:t>
                </a:r>
              </a:p>
            </p:txBody>
          </p:sp>
        </p:grpSp>
      </p:grp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86345635-E1D5-D6F3-B9B7-627AAB9E4972}"/>
              </a:ext>
            </a:extLst>
          </p:cNvPr>
          <p:cNvSpPr txBox="1"/>
          <p:nvPr/>
        </p:nvSpPr>
        <p:spPr>
          <a:xfrm>
            <a:off x="438032" y="5677821"/>
            <a:ext cx="11298252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it-IT" sz="11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it-IT" sz="11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. </a:t>
            </a:r>
            <a:r>
              <a:rPr lang="it-IT" sz="11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-</a:t>
            </a:r>
            <a:r>
              <a:rPr lang="en-US" sz="11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 gene expression and patient BMI and age.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 expression levels of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GF1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, E)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RTN4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, F)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CCL5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C, G) and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L-8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D, H)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BC- AT w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e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quantified by qPCR. Scatter plots show the correlation between mRNA levels and BMI and age of study participants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100" kern="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and p values are shown in the graphs. Dashed lines indicate the 95% confidence intervals for the regression line.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it-IT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72113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o 13">
            <a:extLst>
              <a:ext uri="{FF2B5EF4-FFF2-40B4-BE49-F238E27FC236}">
                <a16:creationId xmlns:a16="http://schemas.microsoft.com/office/drawing/2014/main" id="{251C2566-BB06-4E96-CAFC-6121D080F706}"/>
              </a:ext>
            </a:extLst>
          </p:cNvPr>
          <p:cNvGrpSpPr/>
          <p:nvPr/>
        </p:nvGrpSpPr>
        <p:grpSpPr>
          <a:xfrm>
            <a:off x="-900113" y="-673100"/>
            <a:ext cx="14293851" cy="6477000"/>
            <a:chOff x="-900113" y="-673100"/>
            <a:chExt cx="14293851" cy="6477000"/>
          </a:xfrm>
        </p:grpSpPr>
        <p:graphicFrame>
          <p:nvGraphicFramePr>
            <p:cNvPr id="2" name="Oggetto 1">
              <a:extLst>
                <a:ext uri="{FF2B5EF4-FFF2-40B4-BE49-F238E27FC236}">
                  <a16:creationId xmlns:a16="http://schemas.microsoft.com/office/drawing/2014/main" id="{ADBF5DD9-1D7C-D019-ACAC-DC830639CBB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-900113" y="-673100"/>
            <a:ext cx="14293851" cy="6477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" imgW="9797956" imgH="4439047" progId="Prism8.Document">
                    <p:embed/>
                  </p:oleObj>
                </mc:Choice>
                <mc:Fallback>
                  <p:oleObj name="Prism 8" r:id="rId3" imgW="9797956" imgH="4439047" progId="Prism8.Document">
                    <p:embed/>
                    <p:pic>
                      <p:nvPicPr>
                        <p:cNvPr id="2" name="Oggetto 1">
                          <a:extLst>
                            <a:ext uri="{FF2B5EF4-FFF2-40B4-BE49-F238E27FC236}">
                              <a16:creationId xmlns:a16="http://schemas.microsoft.com/office/drawing/2014/main" id="{ADBF5DD9-1D7C-D019-ACAC-DC830639CBB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900113" y="-673100"/>
                          <a:ext cx="14293851" cy="6477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" name="Gruppo 3">
              <a:extLst>
                <a:ext uri="{FF2B5EF4-FFF2-40B4-BE49-F238E27FC236}">
                  <a16:creationId xmlns:a16="http://schemas.microsoft.com/office/drawing/2014/main" id="{3ABC9A45-47B7-CAAD-6667-9E48E0EEA856}"/>
                </a:ext>
              </a:extLst>
            </p:cNvPr>
            <p:cNvGrpSpPr/>
            <p:nvPr/>
          </p:nvGrpSpPr>
          <p:grpSpPr>
            <a:xfrm>
              <a:off x="386290" y="409441"/>
              <a:ext cx="8925164" cy="250080"/>
              <a:chOff x="288632" y="240763"/>
              <a:chExt cx="8925164" cy="250080"/>
            </a:xfrm>
          </p:grpSpPr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F96D5584-9AF8-818E-4FCA-71B7A6764CE5}"/>
                  </a:ext>
                </a:extLst>
              </p:cNvPr>
              <p:cNvSpPr txBox="1"/>
              <p:nvPr/>
            </p:nvSpPr>
            <p:spPr>
              <a:xfrm>
                <a:off x="288632" y="244622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A</a:t>
                </a:r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46D65AD4-26A7-5DFA-B469-C4017DF743C5}"/>
                  </a:ext>
                </a:extLst>
              </p:cNvPr>
              <p:cNvSpPr txBox="1"/>
              <p:nvPr/>
            </p:nvSpPr>
            <p:spPr>
              <a:xfrm>
                <a:off x="3180468" y="241460"/>
                <a:ext cx="2616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B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F1223E09-A39A-869A-6363-FF4A570D44C2}"/>
                  </a:ext>
                </a:extLst>
              </p:cNvPr>
              <p:cNvSpPr txBox="1"/>
              <p:nvPr/>
            </p:nvSpPr>
            <p:spPr>
              <a:xfrm>
                <a:off x="6109903" y="240764"/>
                <a:ext cx="2728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C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BED0EFA2-88CA-887D-B9CF-A2D34E3128E2}"/>
                  </a:ext>
                </a:extLst>
              </p:cNvPr>
              <p:cNvSpPr txBox="1"/>
              <p:nvPr/>
            </p:nvSpPr>
            <p:spPr>
              <a:xfrm>
                <a:off x="8940964" y="240763"/>
                <a:ext cx="2728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D</a:t>
                </a:r>
              </a:p>
            </p:txBody>
          </p:sp>
        </p:grpSp>
        <p:grpSp>
          <p:nvGrpSpPr>
            <p:cNvPr id="9" name="Gruppo 8">
              <a:extLst>
                <a:ext uri="{FF2B5EF4-FFF2-40B4-BE49-F238E27FC236}">
                  <a16:creationId xmlns:a16="http://schemas.microsoft.com/office/drawing/2014/main" id="{82ABDEB0-D1CD-75D2-A41B-8E22B86D092F}"/>
                </a:ext>
              </a:extLst>
            </p:cNvPr>
            <p:cNvGrpSpPr/>
            <p:nvPr/>
          </p:nvGrpSpPr>
          <p:grpSpPr>
            <a:xfrm>
              <a:off x="386290" y="3178920"/>
              <a:ext cx="8928370" cy="250080"/>
              <a:chOff x="288632" y="240763"/>
              <a:chExt cx="8928370" cy="250080"/>
            </a:xfrm>
          </p:grpSpPr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54F599A2-051A-C4B1-AFAD-018B487E5F15}"/>
                  </a:ext>
                </a:extLst>
              </p:cNvPr>
              <p:cNvSpPr txBox="1"/>
              <p:nvPr/>
            </p:nvSpPr>
            <p:spPr>
              <a:xfrm>
                <a:off x="288632" y="24462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E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B563D096-D4E3-DA0D-4501-D6A3A5FD18C8}"/>
                  </a:ext>
                </a:extLst>
              </p:cNvPr>
              <p:cNvSpPr txBox="1"/>
              <p:nvPr/>
            </p:nvSpPr>
            <p:spPr>
              <a:xfrm>
                <a:off x="3180468" y="241460"/>
                <a:ext cx="2519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F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91F013C8-3B2C-925B-30FC-918DDB72F0E0}"/>
                  </a:ext>
                </a:extLst>
              </p:cNvPr>
              <p:cNvSpPr txBox="1"/>
              <p:nvPr/>
            </p:nvSpPr>
            <p:spPr>
              <a:xfrm>
                <a:off x="6109903" y="240764"/>
                <a:ext cx="2760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G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91C24DA4-1107-0B11-D249-C1B470840C52}"/>
                  </a:ext>
                </a:extLst>
              </p:cNvPr>
              <p:cNvSpPr txBox="1"/>
              <p:nvPr/>
            </p:nvSpPr>
            <p:spPr>
              <a:xfrm>
                <a:off x="8940964" y="240763"/>
                <a:ext cx="2760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H</a:t>
                </a:r>
              </a:p>
            </p:txBody>
          </p:sp>
        </p:grpSp>
      </p:grp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5057B66B-F7F9-4141-20AD-9340C3173F6A}"/>
              </a:ext>
            </a:extLst>
          </p:cNvPr>
          <p:cNvSpPr txBox="1"/>
          <p:nvPr/>
        </p:nvSpPr>
        <p:spPr>
          <a:xfrm>
            <a:off x="461639" y="5657450"/>
            <a:ext cx="11212497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it-IT" sz="11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it-IT" sz="11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. </a:t>
            </a:r>
            <a:r>
              <a:rPr lang="it-IT" sz="11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-</a:t>
            </a:r>
            <a:r>
              <a:rPr lang="en-US" sz="11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 gene expression and patient BMI and age.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 expression levels of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GF1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, E)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RTN4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, F)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CCL5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C, G) and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L-8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D, H)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CTRL- AT w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e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quantified by qPCR. Scatter plots show the correlation between mRNA levels and BMI and age of study participants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100" kern="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and p values are shown in the graphs. Dashed lines indicate the 95% confidence intervals for the regression line.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it-IT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55440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611A556F-9693-3550-F126-9733BA3C0184}"/>
              </a:ext>
            </a:extLst>
          </p:cNvPr>
          <p:cNvSpPr txBox="1"/>
          <p:nvPr/>
        </p:nvSpPr>
        <p:spPr>
          <a:xfrm>
            <a:off x="6263153" y="5107838"/>
            <a:ext cx="5332229" cy="1446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88900" algn="just">
              <a:spcAft>
                <a:spcPts val="800"/>
              </a:spcAft>
            </a:pPr>
            <a:r>
              <a:rPr lang="it-IT" sz="11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it-IT" sz="11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. 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of BC-AT </a:t>
            </a:r>
            <a:r>
              <a:rPr lang="en-US" sz="1100" b="1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CAN, IGF1, RTN4, CCL5 </a:t>
            </a:r>
            <a:r>
              <a:rPr lang="en-US" sz="11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US" sz="1100" b="1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L-8  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circulating tumoral markers.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 expression levels of 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CAN, IGF1, RTN4, CCL5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L-8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BC-AT were quantified by qPCR. C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culating levels of CEA, CA15-3, CA19-9 and CA125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re evaluated in peripheral blood by </a:t>
            </a:r>
            <a:r>
              <a:rPr lang="it-IT" sz="11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CLIA/</a:t>
            </a:r>
            <a:r>
              <a:rPr lang="it-IT" sz="1100" b="0" i="0" dirty="0" err="1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lectrochemiluminescence</a:t>
            </a:r>
            <a:r>
              <a:rPr lang="it-IT" sz="11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mmunoassay</a:t>
            </a:r>
            <a:r>
              <a:rPr lang="it-IT" sz="11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atter plots show the correlation between BC-AT 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CAN (A-D), IGF1 (E-H), RTN4 (I-L), CCL5 (M-P),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L-8 (Q-T)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 levels with circulating tumoral markers CEA, CA15-3, CA19-9, and CA125.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</a:t>
            </a:r>
            <a:r>
              <a:rPr lang="en-US" sz="1100" kern="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and p values are shown in the graphs. Dashed lines indicate the 95% confidence intervals for the regression line.</a:t>
            </a:r>
            <a:endParaRPr lang="it-IT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0" name="Gruppo 29">
            <a:extLst>
              <a:ext uri="{FF2B5EF4-FFF2-40B4-BE49-F238E27FC236}">
                <a16:creationId xmlns:a16="http://schemas.microsoft.com/office/drawing/2014/main" id="{16AD5C0E-4796-D14F-1C54-0424E3D9F5CC}"/>
              </a:ext>
            </a:extLst>
          </p:cNvPr>
          <p:cNvGrpSpPr/>
          <p:nvPr/>
        </p:nvGrpSpPr>
        <p:grpSpPr>
          <a:xfrm>
            <a:off x="135996" y="-346075"/>
            <a:ext cx="5656262" cy="7086600"/>
            <a:chOff x="830263" y="-346075"/>
            <a:chExt cx="5656262" cy="7086600"/>
          </a:xfrm>
        </p:grpSpPr>
        <p:graphicFrame>
          <p:nvGraphicFramePr>
            <p:cNvPr id="2" name="Oggetto 1">
              <a:extLst>
                <a:ext uri="{FF2B5EF4-FFF2-40B4-BE49-F238E27FC236}">
                  <a16:creationId xmlns:a16="http://schemas.microsoft.com/office/drawing/2014/main" id="{E1D2BB05-FEF6-FA44-5C71-47D514DC179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25752749"/>
                </p:ext>
              </p:extLst>
            </p:nvPr>
          </p:nvGraphicFramePr>
          <p:xfrm>
            <a:off x="830263" y="-346075"/>
            <a:ext cx="5656262" cy="7086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" imgW="7905676" imgH="9907943" progId="Prism8.Document">
                    <p:embed/>
                  </p:oleObj>
                </mc:Choice>
                <mc:Fallback>
                  <p:oleObj name="Prism 8" r:id="rId3" imgW="7905676" imgH="9907943" progId="Prism8.Document">
                    <p:embed/>
                    <p:pic>
                      <p:nvPicPr>
                        <p:cNvPr id="2" name="Oggetto 1">
                          <a:extLst>
                            <a:ext uri="{FF2B5EF4-FFF2-40B4-BE49-F238E27FC236}">
                              <a16:creationId xmlns:a16="http://schemas.microsoft.com/office/drawing/2014/main" id="{E1D2BB05-FEF6-FA44-5C71-47D514DC179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30263" y="-346075"/>
                          <a:ext cx="5656262" cy="7086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" name="Gruppo 8">
              <a:extLst>
                <a:ext uri="{FF2B5EF4-FFF2-40B4-BE49-F238E27FC236}">
                  <a16:creationId xmlns:a16="http://schemas.microsoft.com/office/drawing/2014/main" id="{006E342B-FC91-8357-2CC5-D388049B39F8}"/>
                </a:ext>
              </a:extLst>
            </p:cNvPr>
            <p:cNvGrpSpPr/>
            <p:nvPr/>
          </p:nvGrpSpPr>
          <p:grpSpPr>
            <a:xfrm>
              <a:off x="1288828" y="24338"/>
              <a:ext cx="4162266" cy="215444"/>
              <a:chOff x="1288828" y="24338"/>
              <a:chExt cx="4162266" cy="215444"/>
            </a:xfrm>
          </p:grpSpPr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31D3C2BA-0BDB-CE76-6A47-4F5F6ECA6144}"/>
                  </a:ext>
                </a:extLst>
              </p:cNvPr>
              <p:cNvSpPr txBox="1"/>
              <p:nvPr/>
            </p:nvSpPr>
            <p:spPr>
              <a:xfrm>
                <a:off x="1288828" y="24338"/>
                <a:ext cx="2455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A</a:t>
                </a:r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CB873AF5-2849-E148-1690-613963C235D4}"/>
                  </a:ext>
                </a:extLst>
              </p:cNvPr>
              <p:cNvSpPr txBox="1"/>
              <p:nvPr/>
            </p:nvSpPr>
            <p:spPr>
              <a:xfrm>
                <a:off x="5195896" y="24338"/>
                <a:ext cx="2551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D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F2325801-5054-A368-F4D2-B78C86F08A0A}"/>
                  </a:ext>
                </a:extLst>
              </p:cNvPr>
              <p:cNvSpPr txBox="1"/>
              <p:nvPr/>
            </p:nvSpPr>
            <p:spPr>
              <a:xfrm>
                <a:off x="3876377" y="24338"/>
                <a:ext cx="2551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C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8D9A12FA-87F3-1CE5-676F-9BC1455DB1C4}"/>
                  </a:ext>
                </a:extLst>
              </p:cNvPr>
              <p:cNvSpPr txBox="1"/>
              <p:nvPr/>
            </p:nvSpPr>
            <p:spPr>
              <a:xfrm>
                <a:off x="2569902" y="24338"/>
                <a:ext cx="2471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B</a:t>
                </a:r>
              </a:p>
            </p:txBody>
          </p:sp>
        </p:grpSp>
        <p:grpSp>
          <p:nvGrpSpPr>
            <p:cNvPr id="10" name="Gruppo 9">
              <a:extLst>
                <a:ext uri="{FF2B5EF4-FFF2-40B4-BE49-F238E27FC236}">
                  <a16:creationId xmlns:a16="http://schemas.microsoft.com/office/drawing/2014/main" id="{ED8DA724-817F-428F-5692-6907C3BBB9ED}"/>
                </a:ext>
              </a:extLst>
            </p:cNvPr>
            <p:cNvGrpSpPr/>
            <p:nvPr/>
          </p:nvGrpSpPr>
          <p:grpSpPr>
            <a:xfrm>
              <a:off x="1254957" y="1455206"/>
              <a:ext cx="4197738" cy="215444"/>
              <a:chOff x="1254960" y="24338"/>
              <a:chExt cx="4197738" cy="215444"/>
            </a:xfrm>
          </p:grpSpPr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32422DFE-4AC6-4ABB-4B50-92E8AFAC084C}"/>
                  </a:ext>
                </a:extLst>
              </p:cNvPr>
              <p:cNvSpPr txBox="1"/>
              <p:nvPr/>
            </p:nvSpPr>
            <p:spPr>
              <a:xfrm>
                <a:off x="1254960" y="243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E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2D8CB069-02B1-50DD-50B0-F147852A5E35}"/>
                  </a:ext>
                </a:extLst>
              </p:cNvPr>
              <p:cNvSpPr txBox="1"/>
              <p:nvPr/>
            </p:nvSpPr>
            <p:spPr>
              <a:xfrm>
                <a:off x="5195896" y="24338"/>
                <a:ext cx="25680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H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0B72C3FD-9FCA-0564-6DF7-9291B91283CB}"/>
                  </a:ext>
                </a:extLst>
              </p:cNvPr>
              <p:cNvSpPr txBox="1"/>
              <p:nvPr/>
            </p:nvSpPr>
            <p:spPr>
              <a:xfrm>
                <a:off x="3876377" y="24338"/>
                <a:ext cx="25680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G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7D1D581E-F072-A906-90B9-7AA1B4E6FAA1}"/>
                  </a:ext>
                </a:extLst>
              </p:cNvPr>
              <p:cNvSpPr txBox="1"/>
              <p:nvPr/>
            </p:nvSpPr>
            <p:spPr>
              <a:xfrm>
                <a:off x="2569902" y="24338"/>
                <a:ext cx="2391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F</a:t>
                </a:r>
              </a:p>
            </p:txBody>
          </p:sp>
        </p:grpSp>
        <p:grpSp>
          <p:nvGrpSpPr>
            <p:cNvPr id="15" name="Gruppo 14">
              <a:extLst>
                <a:ext uri="{FF2B5EF4-FFF2-40B4-BE49-F238E27FC236}">
                  <a16:creationId xmlns:a16="http://schemas.microsoft.com/office/drawing/2014/main" id="{55D80FFF-417B-F8CA-DF7E-460C75E17632}"/>
                </a:ext>
              </a:extLst>
            </p:cNvPr>
            <p:cNvGrpSpPr/>
            <p:nvPr/>
          </p:nvGrpSpPr>
          <p:grpSpPr>
            <a:xfrm>
              <a:off x="1271894" y="2835280"/>
              <a:ext cx="4143030" cy="215444"/>
              <a:chOff x="1288828" y="24338"/>
              <a:chExt cx="4143030" cy="215444"/>
            </a:xfrm>
          </p:grpSpPr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A4DB7573-69F4-F9E7-ED81-E92CD52C0E85}"/>
                  </a:ext>
                </a:extLst>
              </p:cNvPr>
              <p:cNvSpPr txBox="1"/>
              <p:nvPr/>
            </p:nvSpPr>
            <p:spPr>
              <a:xfrm>
                <a:off x="1288828" y="24338"/>
                <a:ext cx="2119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I</a:t>
                </a:r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2CA133FD-4453-78F8-6754-499542610AC4}"/>
                  </a:ext>
                </a:extLst>
              </p:cNvPr>
              <p:cNvSpPr txBox="1"/>
              <p:nvPr/>
            </p:nvSpPr>
            <p:spPr>
              <a:xfrm>
                <a:off x="5195896" y="24338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L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6FED13A7-A0B3-3B1E-5830-36C25154AB2A}"/>
                  </a:ext>
                </a:extLst>
              </p:cNvPr>
              <p:cNvSpPr txBox="1"/>
              <p:nvPr/>
            </p:nvSpPr>
            <p:spPr>
              <a:xfrm>
                <a:off x="3876377" y="243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K</a:t>
                </a: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7A7C1673-B82E-1849-73CF-DE67A44F4BD7}"/>
                  </a:ext>
                </a:extLst>
              </p:cNvPr>
              <p:cNvSpPr txBox="1"/>
              <p:nvPr/>
            </p:nvSpPr>
            <p:spPr>
              <a:xfrm>
                <a:off x="2595303" y="24338"/>
                <a:ext cx="2183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J</a:t>
                </a:r>
              </a:p>
            </p:txBody>
          </p:sp>
        </p:grpSp>
        <p:grpSp>
          <p:nvGrpSpPr>
            <p:cNvPr id="20" name="Gruppo 19">
              <a:extLst>
                <a:ext uri="{FF2B5EF4-FFF2-40B4-BE49-F238E27FC236}">
                  <a16:creationId xmlns:a16="http://schemas.microsoft.com/office/drawing/2014/main" id="{75A4D1CB-5211-248B-F672-F3EA10AF56C2}"/>
                </a:ext>
              </a:extLst>
            </p:cNvPr>
            <p:cNvGrpSpPr/>
            <p:nvPr/>
          </p:nvGrpSpPr>
          <p:grpSpPr>
            <a:xfrm>
              <a:off x="1246494" y="4223818"/>
              <a:ext cx="4193381" cy="215444"/>
              <a:chOff x="1246493" y="24338"/>
              <a:chExt cx="4193381" cy="215444"/>
            </a:xfrm>
          </p:grpSpPr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DD45E177-46B5-0574-F13E-439064F0ADCC}"/>
                  </a:ext>
                </a:extLst>
              </p:cNvPr>
              <p:cNvSpPr txBox="1"/>
              <p:nvPr/>
            </p:nvSpPr>
            <p:spPr>
              <a:xfrm>
                <a:off x="1246493" y="24338"/>
                <a:ext cx="2664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M</a:t>
                </a:r>
              </a:p>
            </p:txBody>
          </p:sp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id="{2F60350E-95E0-E6DF-1623-3AD457428CAE}"/>
                  </a:ext>
                </a:extLst>
              </p:cNvPr>
              <p:cNvSpPr txBox="1"/>
              <p:nvPr/>
            </p:nvSpPr>
            <p:spPr>
              <a:xfrm>
                <a:off x="5195896" y="24338"/>
                <a:ext cx="2439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P</a:t>
                </a:r>
              </a:p>
            </p:txBody>
          </p:sp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id="{C5241BCD-8D9B-86F7-15AD-E5594E5F180E}"/>
                  </a:ext>
                </a:extLst>
              </p:cNvPr>
              <p:cNvSpPr txBox="1"/>
              <p:nvPr/>
            </p:nvSpPr>
            <p:spPr>
              <a:xfrm>
                <a:off x="3876377" y="24338"/>
                <a:ext cx="2600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O</a:t>
                </a:r>
              </a:p>
            </p:txBody>
          </p: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7DFE6A3C-851F-7E90-918C-29E117E75D16}"/>
                  </a:ext>
                </a:extLst>
              </p:cNvPr>
              <p:cNvSpPr txBox="1"/>
              <p:nvPr/>
            </p:nvSpPr>
            <p:spPr>
              <a:xfrm>
                <a:off x="2569902" y="24338"/>
                <a:ext cx="25680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N</a:t>
                </a:r>
              </a:p>
            </p:txBody>
          </p:sp>
        </p:grpSp>
        <p:grpSp>
          <p:nvGrpSpPr>
            <p:cNvPr id="25" name="Gruppo 24">
              <a:extLst>
                <a:ext uri="{FF2B5EF4-FFF2-40B4-BE49-F238E27FC236}">
                  <a16:creationId xmlns:a16="http://schemas.microsoft.com/office/drawing/2014/main" id="{5A9D6024-EB6A-B9F7-190F-E5A6194B1270}"/>
                </a:ext>
              </a:extLst>
            </p:cNvPr>
            <p:cNvGrpSpPr/>
            <p:nvPr/>
          </p:nvGrpSpPr>
          <p:grpSpPr>
            <a:xfrm>
              <a:off x="1246496" y="5663153"/>
              <a:ext cx="4183763" cy="215444"/>
              <a:chOff x="1288828" y="24338"/>
              <a:chExt cx="4183763" cy="215444"/>
            </a:xfrm>
          </p:grpSpPr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55B67CE3-7944-9483-9663-11B4F3A11DBB}"/>
                  </a:ext>
                </a:extLst>
              </p:cNvPr>
              <p:cNvSpPr txBox="1"/>
              <p:nvPr/>
            </p:nvSpPr>
            <p:spPr>
              <a:xfrm>
                <a:off x="1288828" y="24338"/>
                <a:ext cx="2600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Q</a:t>
                </a: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597F7698-5B18-0241-B690-9A6401D25F30}"/>
                  </a:ext>
                </a:extLst>
              </p:cNvPr>
              <p:cNvSpPr txBox="1"/>
              <p:nvPr/>
            </p:nvSpPr>
            <p:spPr>
              <a:xfrm>
                <a:off x="5238231" y="24338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T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D0B32DC7-94EC-9FC5-C4FF-1690B8D239F9}"/>
                  </a:ext>
                </a:extLst>
              </p:cNvPr>
              <p:cNvSpPr txBox="1"/>
              <p:nvPr/>
            </p:nvSpPr>
            <p:spPr>
              <a:xfrm>
                <a:off x="3918712" y="243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S</a:t>
                </a:r>
              </a:p>
            </p:txBody>
          </p:sp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id="{642BB394-9288-2001-0676-F2EBD2B2F525}"/>
                  </a:ext>
                </a:extLst>
              </p:cNvPr>
              <p:cNvSpPr txBox="1"/>
              <p:nvPr/>
            </p:nvSpPr>
            <p:spPr>
              <a:xfrm>
                <a:off x="2612237" y="24338"/>
                <a:ext cx="2471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R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909811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o 13">
            <a:extLst>
              <a:ext uri="{FF2B5EF4-FFF2-40B4-BE49-F238E27FC236}">
                <a16:creationId xmlns:a16="http://schemas.microsoft.com/office/drawing/2014/main" id="{E573B654-7B24-17F3-4A90-C8AFAB112C94}"/>
              </a:ext>
            </a:extLst>
          </p:cNvPr>
          <p:cNvGrpSpPr/>
          <p:nvPr/>
        </p:nvGrpSpPr>
        <p:grpSpPr>
          <a:xfrm>
            <a:off x="39688" y="462337"/>
            <a:ext cx="12150725" cy="5343151"/>
            <a:chOff x="39688" y="462337"/>
            <a:chExt cx="12150725" cy="5343151"/>
          </a:xfrm>
        </p:grpSpPr>
        <p:graphicFrame>
          <p:nvGraphicFramePr>
            <p:cNvPr id="2" name="Oggetto 1">
              <a:extLst>
                <a:ext uri="{FF2B5EF4-FFF2-40B4-BE49-F238E27FC236}">
                  <a16:creationId xmlns:a16="http://schemas.microsoft.com/office/drawing/2014/main" id="{6E453EEC-C5D1-CFE3-FE8E-B541DA800DF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04275155"/>
                </p:ext>
              </p:extLst>
            </p:nvPr>
          </p:nvGraphicFramePr>
          <p:xfrm>
            <a:off x="39688" y="722313"/>
            <a:ext cx="12150725" cy="5083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" imgW="7055104" imgH="2759826" progId="Prism8.Document">
                    <p:embed/>
                  </p:oleObj>
                </mc:Choice>
                <mc:Fallback>
                  <p:oleObj name="Prism 8" r:id="rId3" imgW="7055104" imgH="2759826" progId="Prism8.Document">
                    <p:embed/>
                    <p:pic>
                      <p:nvPicPr>
                        <p:cNvPr id="2" name="Oggetto 1">
                          <a:extLst>
                            <a:ext uri="{FF2B5EF4-FFF2-40B4-BE49-F238E27FC236}">
                              <a16:creationId xmlns:a16="http://schemas.microsoft.com/office/drawing/2014/main" id="{6E453EEC-C5D1-CFE3-FE8E-B541DA800DF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9688" y="722313"/>
                          <a:ext cx="12150725" cy="5083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" name="Gruppo 3">
              <a:extLst>
                <a:ext uri="{FF2B5EF4-FFF2-40B4-BE49-F238E27FC236}">
                  <a16:creationId xmlns:a16="http://schemas.microsoft.com/office/drawing/2014/main" id="{30296041-660C-43E5-391B-AA6818F19D81}"/>
                </a:ext>
              </a:extLst>
            </p:cNvPr>
            <p:cNvGrpSpPr/>
            <p:nvPr/>
          </p:nvGrpSpPr>
          <p:grpSpPr>
            <a:xfrm>
              <a:off x="264366" y="462337"/>
              <a:ext cx="9212547" cy="250080"/>
              <a:chOff x="288632" y="240763"/>
              <a:chExt cx="9212547" cy="250080"/>
            </a:xfrm>
          </p:grpSpPr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64F0D73C-2D76-9ED2-1913-57AC36D633C4}"/>
                  </a:ext>
                </a:extLst>
              </p:cNvPr>
              <p:cNvSpPr txBox="1"/>
              <p:nvPr/>
            </p:nvSpPr>
            <p:spPr>
              <a:xfrm>
                <a:off x="288632" y="244622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A</a:t>
                </a:r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994EB55D-68F4-FD35-B7EB-DA4221511B86}"/>
                  </a:ext>
                </a:extLst>
              </p:cNvPr>
              <p:cNvSpPr txBox="1"/>
              <p:nvPr/>
            </p:nvSpPr>
            <p:spPr>
              <a:xfrm>
                <a:off x="3276265" y="241460"/>
                <a:ext cx="2616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B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02D6BCA2-914D-940E-5BC6-AE4B4AE0EEC3}"/>
                  </a:ext>
                </a:extLst>
              </p:cNvPr>
              <p:cNvSpPr txBox="1"/>
              <p:nvPr/>
            </p:nvSpPr>
            <p:spPr>
              <a:xfrm>
                <a:off x="6257948" y="240764"/>
                <a:ext cx="2728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C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7109D9F4-597D-46CF-FD1E-6477E7772042}"/>
                  </a:ext>
                </a:extLst>
              </p:cNvPr>
              <p:cNvSpPr txBox="1"/>
              <p:nvPr/>
            </p:nvSpPr>
            <p:spPr>
              <a:xfrm>
                <a:off x="9228347" y="240763"/>
                <a:ext cx="2728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D</a:t>
                </a:r>
              </a:p>
            </p:txBody>
          </p:sp>
        </p:grpSp>
        <p:grpSp>
          <p:nvGrpSpPr>
            <p:cNvPr id="9" name="Gruppo 8">
              <a:extLst>
                <a:ext uri="{FF2B5EF4-FFF2-40B4-BE49-F238E27FC236}">
                  <a16:creationId xmlns:a16="http://schemas.microsoft.com/office/drawing/2014/main" id="{F8A92CA6-4208-09FD-A6DF-01FBC74B6C23}"/>
                </a:ext>
              </a:extLst>
            </p:cNvPr>
            <p:cNvGrpSpPr/>
            <p:nvPr/>
          </p:nvGrpSpPr>
          <p:grpSpPr>
            <a:xfrm>
              <a:off x="264366" y="3261977"/>
              <a:ext cx="9215753" cy="250080"/>
              <a:chOff x="288632" y="240763"/>
              <a:chExt cx="9215753" cy="250080"/>
            </a:xfrm>
          </p:grpSpPr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C2F963AD-955F-2E28-6C4D-52EE51E59269}"/>
                  </a:ext>
                </a:extLst>
              </p:cNvPr>
              <p:cNvSpPr txBox="1"/>
              <p:nvPr/>
            </p:nvSpPr>
            <p:spPr>
              <a:xfrm>
                <a:off x="288632" y="24462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E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EDD9B5E0-BFE6-C23E-A81A-6814B85FE12E}"/>
                  </a:ext>
                </a:extLst>
              </p:cNvPr>
              <p:cNvSpPr txBox="1"/>
              <p:nvPr/>
            </p:nvSpPr>
            <p:spPr>
              <a:xfrm>
                <a:off x="3276265" y="241460"/>
                <a:ext cx="2519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F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01DDE2B1-DAF9-A9C1-C2EE-AAA01EAD1C6E}"/>
                  </a:ext>
                </a:extLst>
              </p:cNvPr>
              <p:cNvSpPr txBox="1"/>
              <p:nvPr/>
            </p:nvSpPr>
            <p:spPr>
              <a:xfrm>
                <a:off x="6257948" y="240764"/>
                <a:ext cx="2760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G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58D5A1FB-E69E-A7E1-E26C-B0076FAEED75}"/>
                  </a:ext>
                </a:extLst>
              </p:cNvPr>
              <p:cNvSpPr txBox="1"/>
              <p:nvPr/>
            </p:nvSpPr>
            <p:spPr>
              <a:xfrm>
                <a:off x="9228347" y="240763"/>
                <a:ext cx="2760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H</a:t>
                </a:r>
              </a:p>
            </p:txBody>
          </p:sp>
        </p:grpSp>
      </p:grp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AF733089-AC32-0D8C-D880-73357B5EFA8E}"/>
              </a:ext>
            </a:extLst>
          </p:cNvPr>
          <p:cNvSpPr txBox="1"/>
          <p:nvPr/>
        </p:nvSpPr>
        <p:spPr>
          <a:xfrm>
            <a:off x="357050" y="5685699"/>
            <a:ext cx="11443063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88900" algn="just">
              <a:spcAft>
                <a:spcPts val="800"/>
              </a:spcAft>
            </a:pPr>
            <a:r>
              <a:rPr lang="it-IT" sz="11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it-IT" sz="11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4. 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of BC-AT </a:t>
            </a:r>
            <a:r>
              <a:rPr lang="en-US" sz="1100" b="1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TN4</a:t>
            </a:r>
            <a:r>
              <a:rPr lang="en-US" sz="11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</a:t>
            </a:r>
            <a:r>
              <a:rPr lang="en-US" sz="1100" b="1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L-8</a:t>
            </a:r>
            <a:r>
              <a:rPr lang="en-US" sz="1100" b="1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tumoral markers.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 expression levels of 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TN4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L-8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BC-AT, and of 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CT4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tumoral tissues were quantified by qPCR. 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, </a:t>
            </a:r>
            <a:r>
              <a:rPr lang="en-US" sz="1100" kern="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GR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Ki67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vels in tumoral tissues were evaluated by immunohistochemical analysis. Scatter plots show the correlation between BC-AT 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TN4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-D) and 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L-8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-H)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RNA levels with tumoral 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CT4, 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, </a:t>
            </a:r>
            <a:r>
              <a:rPr lang="en-US" sz="1100" kern="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GR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i67.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</a:t>
            </a:r>
            <a:r>
              <a:rPr lang="en-US" sz="1100" kern="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and p values are shown in the graphs. Dashed lines indicate the 95% confidence intervals for the regression line.</a:t>
            </a:r>
            <a:endParaRPr lang="it-IT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8825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C937A623-8CD4-4DEC-2C2A-5E08DBBFEA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6914487"/>
              </p:ext>
            </p:extLst>
          </p:nvPr>
        </p:nvGraphicFramePr>
        <p:xfrm>
          <a:off x="0" y="2027238"/>
          <a:ext cx="12319000" cy="2338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7070582" imgH="1340857" progId="Prism8.Document">
                  <p:embed/>
                </p:oleObj>
              </mc:Choice>
              <mc:Fallback>
                <p:oleObj name="Prism 8" r:id="rId3" imgW="7070582" imgH="1340857" progId="Prism8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C937A623-8CD4-4DEC-2C2A-5E08DBBFEA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2027238"/>
                        <a:ext cx="12319000" cy="2338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uppo 3">
            <a:extLst>
              <a:ext uri="{FF2B5EF4-FFF2-40B4-BE49-F238E27FC236}">
                <a16:creationId xmlns:a16="http://schemas.microsoft.com/office/drawing/2014/main" id="{FB519418-60AF-F734-5EC5-C1F8B4266890}"/>
              </a:ext>
            </a:extLst>
          </p:cNvPr>
          <p:cNvGrpSpPr/>
          <p:nvPr/>
        </p:nvGrpSpPr>
        <p:grpSpPr>
          <a:xfrm>
            <a:off x="264366" y="1942794"/>
            <a:ext cx="9212547" cy="250080"/>
            <a:chOff x="288632" y="240763"/>
            <a:chExt cx="9212547" cy="250080"/>
          </a:xfrm>
        </p:grpSpPr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C08DC80A-9D1B-961B-DC4B-15CC407A4090}"/>
                </a:ext>
              </a:extLst>
            </p:cNvPr>
            <p:cNvSpPr txBox="1"/>
            <p:nvPr/>
          </p:nvSpPr>
          <p:spPr>
            <a:xfrm>
              <a:off x="288632" y="244622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A</a:t>
              </a: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1825AE97-6C55-99C3-BA01-30F782A9D190}"/>
                </a:ext>
              </a:extLst>
            </p:cNvPr>
            <p:cNvSpPr txBox="1"/>
            <p:nvPr/>
          </p:nvSpPr>
          <p:spPr>
            <a:xfrm>
              <a:off x="3276265" y="241460"/>
              <a:ext cx="261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B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ECAC3126-F384-4DCB-FB77-1B8269CB37F2}"/>
                </a:ext>
              </a:extLst>
            </p:cNvPr>
            <p:cNvSpPr txBox="1"/>
            <p:nvPr/>
          </p:nvSpPr>
          <p:spPr>
            <a:xfrm>
              <a:off x="6257948" y="240764"/>
              <a:ext cx="2728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C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BC04978E-C8BF-E6E2-5D2E-A9DEEC54800B}"/>
                </a:ext>
              </a:extLst>
            </p:cNvPr>
            <p:cNvSpPr txBox="1"/>
            <p:nvPr/>
          </p:nvSpPr>
          <p:spPr>
            <a:xfrm>
              <a:off x="9228347" y="240763"/>
              <a:ext cx="2728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D</a:t>
              </a:r>
            </a:p>
          </p:txBody>
        </p:sp>
      </p:grp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339E19D3-9CBB-7DFD-732C-77DFB8DD1003}"/>
              </a:ext>
            </a:extLst>
          </p:cNvPr>
          <p:cNvSpPr txBox="1"/>
          <p:nvPr/>
        </p:nvSpPr>
        <p:spPr>
          <a:xfrm>
            <a:off x="296213" y="4367929"/>
            <a:ext cx="11599695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88900" algn="just">
              <a:spcAft>
                <a:spcPts val="800"/>
              </a:spcAft>
            </a:pPr>
            <a:r>
              <a:rPr lang="it-IT" sz="11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it-IT" sz="11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5. 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of BC-AT </a:t>
            </a:r>
            <a:r>
              <a:rPr lang="en-US" sz="1100" b="1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CL5 </a:t>
            </a:r>
            <a:r>
              <a:rPr lang="en-US" sz="11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tumoral markers.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 expression levels of 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CL5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BC-AT, and of 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CT4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tumoral tissues were quantified by qPCR. 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, </a:t>
            </a:r>
            <a:r>
              <a:rPr lang="en-US" sz="1100" kern="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GR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Ki67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vels in tumoral tissues were evaluated by immunohistochemical analysis. Scatter plots show the correlation between BC-AT 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CL5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 levels with tumoral 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CT4 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100" i="1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 (B), </a:t>
            </a:r>
            <a:r>
              <a:rPr lang="en-US" sz="1100" kern="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GR</a:t>
            </a:r>
            <a:r>
              <a:rPr lang="en-US" sz="1100" kern="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) and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i67 (D).</a:t>
            </a:r>
            <a:r>
              <a:rPr lang="en-US" sz="1100" i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</a:t>
            </a:r>
            <a:r>
              <a:rPr lang="en-US" sz="1100" kern="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and p values are shown in the graphs. Dashed lines indicate the 95% confidence intervals for the regression line.</a:t>
            </a:r>
            <a:endParaRPr lang="it-IT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168677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</TotalTime>
  <Words>575</Words>
  <Application>Microsoft Office PowerPoint</Application>
  <PresentationFormat>Widescreen</PresentationFormat>
  <Paragraphs>63</Paragraphs>
  <Slides>5</Slides>
  <Notes>5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Tema di Office</vt:lpstr>
      <vt:lpstr>Prism 8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ESSIA PARASCANDOLO</dc:creator>
  <cp:lastModifiedBy>PIETRO FORMISANO</cp:lastModifiedBy>
  <cp:revision>23</cp:revision>
  <dcterms:created xsi:type="dcterms:W3CDTF">2024-09-17T15:22:54Z</dcterms:created>
  <dcterms:modified xsi:type="dcterms:W3CDTF">2024-09-27T12:03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ad0b24d-6422-44b0-b3de-abb3a9e8c81a_Enabled">
    <vt:lpwstr>true</vt:lpwstr>
  </property>
  <property fmtid="{D5CDD505-2E9C-101B-9397-08002B2CF9AE}" pid="3" name="MSIP_Label_2ad0b24d-6422-44b0-b3de-abb3a9e8c81a_SetDate">
    <vt:lpwstr>2024-09-17T15:24:27Z</vt:lpwstr>
  </property>
  <property fmtid="{D5CDD505-2E9C-101B-9397-08002B2CF9AE}" pid="4" name="MSIP_Label_2ad0b24d-6422-44b0-b3de-abb3a9e8c81a_Method">
    <vt:lpwstr>Standard</vt:lpwstr>
  </property>
  <property fmtid="{D5CDD505-2E9C-101B-9397-08002B2CF9AE}" pid="5" name="MSIP_Label_2ad0b24d-6422-44b0-b3de-abb3a9e8c81a_Name">
    <vt:lpwstr>defa4170-0d19-0005-0004-bc88714345d2</vt:lpwstr>
  </property>
  <property fmtid="{D5CDD505-2E9C-101B-9397-08002B2CF9AE}" pid="6" name="MSIP_Label_2ad0b24d-6422-44b0-b3de-abb3a9e8c81a_SiteId">
    <vt:lpwstr>2fcfe26a-bb62-46b0-b1e3-28f9da0c45fd</vt:lpwstr>
  </property>
  <property fmtid="{D5CDD505-2E9C-101B-9397-08002B2CF9AE}" pid="7" name="MSIP_Label_2ad0b24d-6422-44b0-b3de-abb3a9e8c81a_ActionId">
    <vt:lpwstr>a9b0b16d-e5f0-4dce-923e-7a0bc1d76d76</vt:lpwstr>
  </property>
  <property fmtid="{D5CDD505-2E9C-101B-9397-08002B2CF9AE}" pid="8" name="MSIP_Label_2ad0b24d-6422-44b0-b3de-abb3a9e8c81a_ContentBits">
    <vt:lpwstr>0</vt:lpwstr>
  </property>
</Properties>
</file>